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90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21B93"/>
    <a:srgbClr val="0432FF"/>
    <a:srgbClr val="521A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12" autoAdjust="0"/>
    <p:restoredTop sz="95179"/>
  </p:normalViewPr>
  <p:slideViewPr>
    <p:cSldViewPr snapToGrid="0">
      <p:cViewPr varScale="1">
        <p:scale>
          <a:sx n="90" d="100"/>
          <a:sy n="90" d="100"/>
        </p:scale>
        <p:origin x="1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AEF05-FA34-D244-A8F0-7BF607636C2E}" type="datetimeFigureOut">
              <a:rPr lang="en-US" smtClean="0"/>
              <a:t>1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46350F-9E8D-BA4B-B3F3-60489CB49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960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ADE96-D1DD-F70E-79EC-A6122FD75A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222708-A837-4C90-A3C6-D85792FF56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55F1E-D5CB-4BD6-3D53-34F2AA1C4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AF33EF-2DD4-7D32-0CBF-A8886A50A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896F50-89F6-2012-076F-BC1F798D4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367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E8D4A-298F-5DEC-8524-555AAB0A79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0CC507-50EA-0BDB-2EA8-95CC809219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88118C-7CC4-0415-31AA-992A843B9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E5A391-9AF1-82F1-631C-0FD73F6D8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21C8C9-62C8-399F-88DA-135A1AA12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742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11F30B-6844-2EE2-F0CA-AC6E21F9AA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09250A-B423-2F34-3CAF-62D36867C0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5D873F-3BD7-0FA8-52C9-4C0782CF7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F89220-9926-10CB-9838-891153D79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C0A9EE-2EFD-0D77-065C-0C0EE150C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535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0F1AA5-BB3E-852F-7F17-1EAEC2986B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E77562-91E7-D810-82BE-0ED456AF1A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B08DD4-FC0B-ABF9-24F0-1DAE49B40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C0BCD2-6BE7-4FDB-8D7B-D65835AEE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500661-315E-9E1C-46BB-8BF864CA0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08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C86843-B5A5-4199-8F38-A8766FB8C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CE3581-223E-CB18-3B86-B9C7157875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4DD69-6CAA-1594-4D6E-39B4262DB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D78B10-6690-FC97-0C91-DE6450152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F1D78A-47E6-D288-8429-9ED7EDA65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932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9CA3E8-9C2F-67CE-09E1-92D5E81345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950F42-CE5D-94F6-88E2-40703D7207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37F688-8A86-6A33-9A80-DDFEB18F3E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35B9A9-A7E0-32DF-9D08-5FB3D098D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2264A7-E13F-8257-7161-A91A3F54A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0C8801-44C8-13DC-CEC0-121E12024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97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956D9-E2C8-A490-7931-F743BF78F2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8B37F8-5031-0FDB-C583-3EF6D723E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FBCB1-E6EE-D5BC-49C0-1BD665701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3FC95F-457F-3B34-9B95-DC1ED53A31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027767-A3C1-A649-1A20-5D6F0B4005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524AF5-E4FB-524D-2F8F-4BBC219B0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DD4361-1740-B1BE-EBF2-E654B34DA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2464AA-BD6E-9E2B-6371-E234F531B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384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F902D-66E7-B592-763E-292953B86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E66254-BE5F-8BCB-6389-7D557ED1F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575602-A8F3-7AAC-2B4B-870F78039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4E1EFF-4227-C502-2DF4-DBB12D06A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23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39A049-911F-C507-EDFC-B696F647A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B3956A-ABA8-D21E-FE4D-D1CCC865E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19AD141-2BF6-FE24-EBD6-170A444FA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38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A089A-2E38-E3BB-9CAC-C40F5D76B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14CA9E-3438-46B7-FB39-0E1BB1008D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AFB302-FBBD-33EA-5493-0C5443F51A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80CB2B-133B-F712-D931-1CC52C33B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EC33D9-DD51-D4B9-3175-E01BD1AC2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7D3B0F-380B-259F-2ACB-A0E7B7C44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661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C91C0-64C0-4478-802A-FD5014C6B9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CAD7FF-FBC1-F443-75E9-D8ED8FDE0D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CF01B0-7D3C-E2E2-C989-9CFB4E7A04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040DD-B5BB-5685-220C-22EC1AAB4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28A5FC-C552-E6B5-5E1A-82A65D94C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31F3A1-1181-D962-CBDD-80ADF036C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634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3CA8F1-EA0F-6165-915B-4DFC17328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F38115-FF51-F1AE-A40E-D3F95A2F17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73A3E0-A93B-57AA-26E9-F9069D1947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3BA49-6630-E14C-B8C7-274F17AADE14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0FF6A0-2662-A24F-BBDB-7A32D32412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A6DA0-19DE-8F12-95E0-50E4120378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083FC-370A-4E4C-8615-25807A024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166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13" Type="http://schemas.microsoft.com/office/2007/relationships/hdphoto" Target="../media/hdphoto1.wdp"/><Relationship Id="rId18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12" Type="http://schemas.openxmlformats.org/officeDocument/2006/relationships/image" Target="../media/image9.png"/><Relationship Id="rId1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package" Target="../embeddings/Microsoft_Word_Document1.docx"/><Relationship Id="rId11" Type="http://schemas.openxmlformats.org/officeDocument/2006/relationships/image" Target="../media/image8.png"/><Relationship Id="rId5" Type="http://schemas.openxmlformats.org/officeDocument/2006/relationships/image" Target="../media/image3.emf"/><Relationship Id="rId15" Type="http://schemas.microsoft.com/office/2007/relationships/hdphoto" Target="../media/hdphoto2.wdp"/><Relationship Id="rId10" Type="http://schemas.openxmlformats.org/officeDocument/2006/relationships/image" Target="../media/image7.png"/><Relationship Id="rId19" Type="http://schemas.openxmlformats.org/officeDocument/2006/relationships/image" Target="../media/image13.png"/><Relationship Id="rId4" Type="http://schemas.openxmlformats.org/officeDocument/2006/relationships/package" Target="../embeddings/Microsoft_Word_Document.docx"/><Relationship Id="rId9" Type="http://schemas.openxmlformats.org/officeDocument/2006/relationships/image" Target="../media/image6.JPG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>
            <a:extLst>
              <a:ext uri="{FF2B5EF4-FFF2-40B4-BE49-F238E27FC236}">
                <a16:creationId xmlns:a16="http://schemas.microsoft.com/office/drawing/2014/main" id="{66E04F1E-BA38-BFDF-0DDF-7B21DC285C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330" y="306121"/>
            <a:ext cx="3202152" cy="1819567"/>
          </a:xfrm>
          <a:prstGeom prst="rect">
            <a:avLst/>
          </a:prstGeom>
        </p:spPr>
      </p:pic>
      <p:grpSp>
        <p:nvGrpSpPr>
          <p:cNvPr id="32" name="Group 31">
            <a:extLst>
              <a:ext uri="{FF2B5EF4-FFF2-40B4-BE49-F238E27FC236}">
                <a16:creationId xmlns:a16="http://schemas.microsoft.com/office/drawing/2014/main" id="{6C44AFBE-EC4A-308B-D016-2B05AC1DF9D1}"/>
              </a:ext>
            </a:extLst>
          </p:cNvPr>
          <p:cNvGrpSpPr/>
          <p:nvPr/>
        </p:nvGrpSpPr>
        <p:grpSpPr>
          <a:xfrm>
            <a:off x="457713" y="89261"/>
            <a:ext cx="11189492" cy="6679478"/>
            <a:chOff x="457713" y="89261"/>
            <a:chExt cx="11189492" cy="6679478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85989F26-47B6-544B-A3D7-291A34875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99748" y="201271"/>
              <a:ext cx="4757766" cy="2009823"/>
            </a:xfrm>
            <a:prstGeom prst="rect">
              <a:avLst/>
            </a:prstGeom>
          </p:spPr>
        </p:pic>
        <p:sp>
          <p:nvSpPr>
            <p:cNvPr id="11" name="Rectangle 6">
              <a:extLst>
                <a:ext uri="{FF2B5EF4-FFF2-40B4-BE49-F238E27FC236}">
                  <a16:creationId xmlns:a16="http://schemas.microsoft.com/office/drawing/2014/main" id="{97F8E8DC-FBEA-C556-BAE8-8E11EEFE4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795" y="5445300"/>
              <a:ext cx="10861243" cy="1323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. S1 a-n. 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Amplification of Cas9 (lines 5a, b and 7a, b are Cas-free)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. 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lification of the hygromycin gene in edited plants (lines 5a and 9a, b are marker-free).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. 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ino acid sequences of the short ORFs of the NE (up to 194 aa) and edited plants.  Highlighted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H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 are the histidine residues in the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binding domain, which are less in the edited plants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Predicted (using DNASTAR) model of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O-2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of NE plants with two Cu-binding sites (pink spheres)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-g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Predicted model of the short ORF of 23 b deleted, 1-b inserted and 1-b deleted plants with no Cu-A binding domain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h-l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Changes in the Cu-binding domains by genome-editing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h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Enlarged portion of the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 (with 3 pairs of Histidine and 1 Cysteine) and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B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binding (with 3 pairs of Histidine and 1 each phenylalanine in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 and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B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binding) domain showing the relationship (with 3 pairs of Histidine and 1 Cysteine binding in) of the full ORF of NE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O2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; </a:t>
              </a:r>
              <a:r>
                <a:rPr lang="en-US" sz="1000" b="1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&amp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j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Short ORF of 23-b deleted and 1-b inserted showing no </a:t>
              </a:r>
              <a:r>
                <a:rPr lang="en-US" sz="1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A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binding (only 1 Histidine)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k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1-b deleted showing two histidine and 1 glutamic acid)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l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Large ORF of the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O2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starting at 237 aa) showing changes in binding site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Multiple sequence analysis of the small ORF with the ORF of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O2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up to 194 aa); </a:t>
              </a:r>
              <a:r>
                <a:rPr lang="en-US" sz="1000" b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Multiple sequence analysis of the large ORF with the ORF of </a:t>
              </a:r>
              <a:r>
                <a:rPr lang="en-US" sz="10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O2</a:t>
              </a:r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(starting at 237 aa).  (M- 1kb plus marker; N- negative control; NE-Non-Edited, 1-12 are edited lines; a, b represent the biological replicates) </a:t>
              </a:r>
              <a:endParaRPr lang="en-IN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44669158-A0CC-688A-8BE6-DB386D78792F}"/>
                </a:ext>
              </a:extLst>
            </p:cNvPr>
            <p:cNvGrpSpPr/>
            <p:nvPr/>
          </p:nvGrpSpPr>
          <p:grpSpPr>
            <a:xfrm>
              <a:off x="8405376" y="1612622"/>
              <a:ext cx="3241829" cy="3992348"/>
              <a:chOff x="7608880" y="444154"/>
              <a:chExt cx="4184688" cy="5203715"/>
            </a:xfrm>
          </p:grpSpPr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43A4198C-C488-2312-3901-1B123C16446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21109153"/>
                  </p:ext>
                </p:extLst>
              </p:nvPr>
            </p:nvGraphicFramePr>
            <p:xfrm>
              <a:off x="8013701" y="532136"/>
              <a:ext cx="3755632" cy="207041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Document" r:id="rId4" imgW="5943600" imgH="3276600" progId="Word.Document.12">
                      <p:embed/>
                    </p:oleObj>
                  </mc:Choice>
                  <mc:Fallback>
                    <p:oleObj name="Document" r:id="rId4" imgW="5943600" imgH="3276600" progId="Word.Document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8013701" y="532136"/>
                            <a:ext cx="3755632" cy="207041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2D5C16B7-F565-1B58-BD95-996C672F1F3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33118340"/>
                  </p:ext>
                </p:extLst>
              </p:nvPr>
            </p:nvGraphicFramePr>
            <p:xfrm>
              <a:off x="8051172" y="2681141"/>
              <a:ext cx="3742396" cy="296672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Document" r:id="rId6" imgW="5943600" imgH="4711700" progId="Word.Document.12">
                      <p:embed/>
                    </p:oleObj>
                  </mc:Choice>
                  <mc:Fallback>
                    <p:oleObj name="Document" r:id="rId6" imgW="5943600" imgH="4711700" progId="Word.Document.12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3A7378D4-5300-A664-9F59-4C451DAB521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8051172" y="2681141"/>
                            <a:ext cx="3742396" cy="296672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4B1656D-91CA-64A1-EE99-409F59A6ACDB}"/>
                  </a:ext>
                </a:extLst>
              </p:cNvPr>
              <p:cNvSpPr txBox="1"/>
              <p:nvPr/>
            </p:nvSpPr>
            <p:spPr>
              <a:xfrm>
                <a:off x="7608880" y="444154"/>
                <a:ext cx="325315" cy="48139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FF03056-8BE2-8141-B1E7-8DACE91DB94D}"/>
                  </a:ext>
                </a:extLst>
              </p:cNvPr>
              <p:cNvSpPr txBox="1"/>
              <p:nvPr/>
            </p:nvSpPr>
            <p:spPr>
              <a:xfrm>
                <a:off x="7699678" y="2602551"/>
                <a:ext cx="325315" cy="48139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95B2543-CF37-2F0E-5EAE-B609A6500A58}"/>
                </a:ext>
              </a:extLst>
            </p:cNvPr>
            <p:cNvSpPr txBox="1"/>
            <p:nvPr/>
          </p:nvSpPr>
          <p:spPr>
            <a:xfrm>
              <a:off x="3351886" y="89261"/>
              <a:ext cx="32531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473D81AA-8BE7-07F3-5E21-1FC5B56CEC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561" t="9494" r="5573" b="8204"/>
            <a:stretch/>
          </p:blipFill>
          <p:spPr>
            <a:xfrm>
              <a:off x="9743214" y="264541"/>
              <a:ext cx="1662824" cy="1191068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01481FD-6361-A33E-C768-EFCE9522388C}"/>
                </a:ext>
              </a:extLst>
            </p:cNvPr>
            <p:cNvSpPr txBox="1"/>
            <p:nvPr/>
          </p:nvSpPr>
          <p:spPr>
            <a:xfrm>
              <a:off x="9666646" y="146552"/>
              <a:ext cx="32531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44828C5-BEE6-B412-53F8-E41492EE55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313" t="4787" r="19463" b="5788"/>
            <a:stretch/>
          </p:blipFill>
          <p:spPr>
            <a:xfrm>
              <a:off x="8321963" y="255526"/>
              <a:ext cx="1401564" cy="1191068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6910C61-A9FC-EFE3-2A0C-91BFF91B5F6A}"/>
                </a:ext>
              </a:extLst>
            </p:cNvPr>
            <p:cNvSpPr txBox="1"/>
            <p:nvPr/>
          </p:nvSpPr>
          <p:spPr>
            <a:xfrm>
              <a:off x="8288675" y="179658"/>
              <a:ext cx="32531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711F018-EFE4-40CD-8D72-8C33BC7A124D}"/>
                </a:ext>
              </a:extLst>
            </p:cNvPr>
            <p:cNvGrpSpPr/>
            <p:nvPr/>
          </p:nvGrpSpPr>
          <p:grpSpPr>
            <a:xfrm>
              <a:off x="463546" y="3511218"/>
              <a:ext cx="1580377" cy="1481635"/>
              <a:chOff x="10027571" y="227855"/>
              <a:chExt cx="1414447" cy="1288080"/>
            </a:xfrm>
          </p:grpSpPr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AB6F5264-EB56-E00C-F9F0-6D7466B911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11"/>
              <a:stretch/>
            </p:blipFill>
            <p:spPr bwMode="auto">
              <a:xfrm>
                <a:off x="10082039" y="312686"/>
                <a:ext cx="1359979" cy="120324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07CE8637-A296-B5A1-16B0-CD7B3CE6CEAA}"/>
                  </a:ext>
                </a:extLst>
              </p:cNvPr>
              <p:cNvSpPr txBox="1"/>
              <p:nvPr/>
            </p:nvSpPr>
            <p:spPr>
              <a:xfrm>
                <a:off x="10027571" y="227855"/>
                <a:ext cx="224677" cy="3210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2253294B-AFEB-428E-91F4-42D1C323304F}"/>
                </a:ext>
              </a:extLst>
            </p:cNvPr>
            <p:cNvGrpSpPr/>
            <p:nvPr/>
          </p:nvGrpSpPr>
          <p:grpSpPr>
            <a:xfrm>
              <a:off x="457713" y="2297019"/>
              <a:ext cx="1586214" cy="1280645"/>
              <a:chOff x="8476138" y="235290"/>
              <a:chExt cx="1586214" cy="1280645"/>
            </a:xfrm>
          </p:grpSpPr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3659E74D-90F9-8179-2523-C9C9BB7B7C8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10284" r="15511"/>
              <a:stretch/>
            </p:blipFill>
            <p:spPr>
              <a:xfrm>
                <a:off x="8531385" y="309521"/>
                <a:ext cx="1530967" cy="1206414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B87EF63-FC63-70EA-337D-596855C643E2}"/>
                  </a:ext>
                </a:extLst>
              </p:cNvPr>
              <p:cNvSpPr txBox="1"/>
              <p:nvPr/>
            </p:nvSpPr>
            <p:spPr>
              <a:xfrm>
                <a:off x="8476138" y="235290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DCB0AD8-7707-4D3D-A23D-E0C3E97E2BA3}"/>
                </a:ext>
              </a:extLst>
            </p:cNvPr>
            <p:cNvGrpSpPr/>
            <p:nvPr/>
          </p:nvGrpSpPr>
          <p:grpSpPr>
            <a:xfrm>
              <a:off x="2277032" y="2183664"/>
              <a:ext cx="6124939" cy="3249891"/>
              <a:chOff x="1664915" y="2183664"/>
              <a:chExt cx="6124939" cy="3249891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A9F349FF-19E6-7754-3F7E-667033071E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29000"/>
                        </a14:imgEffect>
                        <a14:imgEffect>
                          <a14:brightnessContrast bright="-3000"/>
                        </a14:imgEffect>
                      </a14:imgLayer>
                    </a14:imgProps>
                  </a:ext>
                </a:extLst>
              </a:blip>
              <a:srcRect l="15008" t="30046" r="37187" b="16883"/>
              <a:stretch/>
            </p:blipFill>
            <p:spPr bwMode="auto">
              <a:xfrm>
                <a:off x="1695071" y="2227275"/>
                <a:ext cx="3007671" cy="1685646"/>
              </a:xfrm>
              <a:prstGeom prst="rect">
                <a:avLst/>
              </a:prstGeom>
              <a:ln>
                <a:solidFill>
                  <a:srgbClr val="FF0000"/>
                </a:solidFill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932D76EE-FD73-6AD0-8F80-AEA980D520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48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732898" y="2231137"/>
                <a:ext cx="3052900" cy="756985"/>
              </a:xfrm>
              <a:prstGeom prst="rect">
                <a:avLst/>
              </a:prstGeom>
              <a:ln>
                <a:solidFill>
                  <a:srgbClr val="FF0000"/>
                </a:solidFill>
              </a:ln>
            </p:spPr>
          </p:pic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FED73490-FC4B-74DF-4C2F-3C2DB23FD9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39000"/>
                        </a14:imgEffect>
                      </a14:imgLayer>
                    </a14:imgProps>
                  </a:ext>
                </a:extLst>
              </a:blip>
              <a:srcRect r="4094"/>
              <a:stretch/>
            </p:blipFill>
            <p:spPr>
              <a:xfrm>
                <a:off x="1695070" y="3938334"/>
                <a:ext cx="3007672" cy="1495221"/>
              </a:xfrm>
              <a:prstGeom prst="rect">
                <a:avLst/>
              </a:prstGeom>
              <a:ln>
                <a:solidFill>
                  <a:srgbClr val="FF0000"/>
                </a:solidFill>
              </a:ln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C07E740D-018C-7344-AED3-81F53AD906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4732898" y="3013535"/>
                <a:ext cx="3056956" cy="855472"/>
              </a:xfrm>
              <a:prstGeom prst="rect">
                <a:avLst/>
              </a:prstGeom>
              <a:ln>
                <a:solidFill>
                  <a:srgbClr val="FF0000"/>
                </a:solidFill>
              </a:ln>
            </p:spPr>
          </p:pic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D323A82-FD62-570C-E582-E2D129A610AF}"/>
                  </a:ext>
                </a:extLst>
              </p:cNvPr>
              <p:cNvSpPr txBox="1"/>
              <p:nvPr/>
            </p:nvSpPr>
            <p:spPr>
              <a:xfrm>
                <a:off x="1664915" y="2231137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2E8EA51D-367D-787F-7415-F4CC3CDF2262}"/>
                  </a:ext>
                </a:extLst>
              </p:cNvPr>
              <p:cNvSpPr txBox="1"/>
              <p:nvPr/>
            </p:nvSpPr>
            <p:spPr>
              <a:xfrm>
                <a:off x="4702068" y="2993523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B7EAE53-4549-53F9-37E0-5413FBB47185}"/>
                  </a:ext>
                </a:extLst>
              </p:cNvPr>
              <p:cNvSpPr txBox="1"/>
              <p:nvPr/>
            </p:nvSpPr>
            <p:spPr>
              <a:xfrm>
                <a:off x="1695070" y="3885858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</a:t>
                </a:r>
              </a:p>
            </p:txBody>
          </p:sp>
          <p:pic>
            <p:nvPicPr>
              <p:cNvPr id="1317" name="Picture 1316">
                <a:extLst>
                  <a:ext uri="{FF2B5EF4-FFF2-40B4-BE49-F238E27FC236}">
                    <a16:creationId xmlns:a16="http://schemas.microsoft.com/office/drawing/2014/main" id="{F7DD4C0A-8F10-100E-3923-7A34922FE3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b="12308"/>
              <a:stretch/>
            </p:blipFill>
            <p:spPr>
              <a:xfrm>
                <a:off x="4732391" y="3894420"/>
                <a:ext cx="3056956" cy="1539135"/>
              </a:xfrm>
              <a:prstGeom prst="rect">
                <a:avLst/>
              </a:prstGeom>
              <a:ln>
                <a:solidFill>
                  <a:srgbClr val="FF0000"/>
                </a:solidFill>
              </a:ln>
            </p:spPr>
          </p:pic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BDC6DF95-DE39-9813-8130-3656CE3BA596}"/>
                  </a:ext>
                </a:extLst>
              </p:cNvPr>
              <p:cNvSpPr txBox="1"/>
              <p:nvPr/>
            </p:nvSpPr>
            <p:spPr>
              <a:xfrm>
                <a:off x="4732391" y="2183664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8A2FCCAD-D145-1AAA-0360-49193574C953}"/>
                  </a:ext>
                </a:extLst>
              </p:cNvPr>
              <p:cNvSpPr txBox="1"/>
              <p:nvPr/>
            </p:nvSpPr>
            <p:spPr>
              <a:xfrm>
                <a:off x="4693849" y="3818622"/>
                <a:ext cx="32531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</a:t>
                </a: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E587270-409D-48E0-9DBD-5F1B16F1E271}"/>
                </a:ext>
              </a:extLst>
            </p:cNvPr>
            <p:cNvSpPr txBox="1"/>
            <p:nvPr/>
          </p:nvSpPr>
          <p:spPr>
            <a:xfrm>
              <a:off x="634862" y="300620"/>
              <a:ext cx="32531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7EE57A1-3E2B-477F-8CCE-6640A2075375}"/>
                </a:ext>
              </a:extLst>
            </p:cNvPr>
            <p:cNvSpPr txBox="1"/>
            <p:nvPr/>
          </p:nvSpPr>
          <p:spPr>
            <a:xfrm>
              <a:off x="620370" y="1184716"/>
              <a:ext cx="32531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16221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40E8458-3133-712C-3D95-A36C7DFC26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4312"/>
          <a:stretch/>
        </p:blipFill>
        <p:spPr>
          <a:xfrm>
            <a:off x="7476428" y="878191"/>
            <a:ext cx="4095341" cy="23698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EDFA2C8-673F-BE9E-D007-6D1E95CCCB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86614" y="3027611"/>
            <a:ext cx="4274968" cy="2282723"/>
          </a:xfrm>
          <a:prstGeom prst="rect">
            <a:avLst/>
          </a:prstGeom>
        </p:spPr>
      </p:pic>
      <p:sp>
        <p:nvSpPr>
          <p:cNvPr id="6" name="Rectangle 6">
            <a:extLst>
              <a:ext uri="{FF2B5EF4-FFF2-40B4-BE49-F238E27FC236}">
                <a16:creationId xmlns:a16="http://schemas.microsoft.com/office/drawing/2014/main" id="{9F9720C0-EDE0-7D4D-6057-F30A6A6C8F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6614" y="5340384"/>
            <a:ext cx="4274968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a &amp; b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ultiple sequence analysis of the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binding region of the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PO2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in different plant species of Solanaceae showing the conserved sequence;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IN" sz="1200" b="0" i="0" u="none" strike="noStrike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endrogram generated by </a:t>
            </a:r>
            <a:r>
              <a:rPr lang="en-IN" sz="1200" b="0" i="0" u="none" strike="noStrike" dirty="0" err="1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ighbor</a:t>
            </a:r>
            <a:r>
              <a:rPr lang="en-IN" sz="12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200" b="0" i="0" u="none" strike="noStrike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joining clustering showing the relationships of </a:t>
            </a:r>
            <a:r>
              <a:rPr lang="en-IN" sz="1200" b="0" i="0" u="none" strike="noStrike" dirty="0" err="1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uA</a:t>
            </a:r>
            <a:r>
              <a:rPr lang="en-IN" sz="12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200" b="0" i="0" u="none" strike="noStrike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nding conserved domains of different plant species of Solanaceae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94E213D-E1E7-0BFC-E02C-2683B63518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133" y="878191"/>
            <a:ext cx="6375400" cy="405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9454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E702362-6BD0-20F7-5A67-5B188B971F84}"/>
              </a:ext>
            </a:extLst>
          </p:cNvPr>
          <p:cNvSpPr txBox="1"/>
          <p:nvPr/>
        </p:nvSpPr>
        <p:spPr>
          <a:xfrm>
            <a:off x="324807" y="636272"/>
            <a:ext cx="3605020" cy="2766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tails of Edited lines (NE- Non-Edited)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9CB94CA-6409-46C3-9D07-5600A2C141BE}"/>
              </a:ext>
            </a:extLst>
          </p:cNvPr>
          <p:cNvSpPr txBox="1"/>
          <p:nvPr/>
        </p:nvSpPr>
        <p:spPr>
          <a:xfrm>
            <a:off x="3580307" y="290005"/>
            <a:ext cx="269965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quences of the primers used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0AAAF4-06EB-C62D-9394-663B1024DA90}"/>
              </a:ext>
            </a:extLst>
          </p:cNvPr>
          <p:cNvSpPr txBox="1"/>
          <p:nvPr/>
        </p:nvSpPr>
        <p:spPr>
          <a:xfrm>
            <a:off x="3416343" y="4543865"/>
            <a:ext cx="370683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SmPPO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– Target (underline bases are the adapters).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PPO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FL – PCR for sequencing;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PPO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T for confirming the 23-b editing paired with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PPO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FL.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F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R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– qPCR. Cas and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yg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o check for the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bsence of 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s and hygromycin in edited plants, respectively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25FF4C-1BE6-2C79-1C78-573418E4458A}"/>
              </a:ext>
            </a:extLst>
          </p:cNvPr>
          <p:cNvSpPr txBox="1"/>
          <p:nvPr/>
        </p:nvSpPr>
        <p:spPr>
          <a:xfrm>
            <a:off x="371950" y="3997034"/>
            <a:ext cx="306056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a, b are biological replicates of the same line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0BC467C-0D97-FB65-273F-4F5A00F83B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340" y="912951"/>
            <a:ext cx="2939787" cy="31305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3CA9406-4EE8-8158-3941-CDCB61C9D4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0307" y="567004"/>
            <a:ext cx="3224178" cy="3976861"/>
          </a:xfrm>
          <a:prstGeom prst="rect">
            <a:avLst/>
          </a:prstGeom>
        </p:spPr>
      </p:pic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4E5A1137-C3C2-E667-9CA8-C55B9F1437A5}"/>
              </a:ext>
            </a:extLst>
          </p:cNvPr>
          <p:cNvGraphicFramePr>
            <a:graphicFrameLocks noGrp="1"/>
          </p:cNvGraphicFramePr>
          <p:nvPr/>
        </p:nvGraphicFramePr>
        <p:xfrm>
          <a:off x="7287146" y="567004"/>
          <a:ext cx="4532903" cy="57212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45942">
                  <a:extLst>
                    <a:ext uri="{9D8B030D-6E8A-4147-A177-3AD203B41FA5}">
                      <a16:colId xmlns:a16="http://schemas.microsoft.com/office/drawing/2014/main" val="1383899188"/>
                    </a:ext>
                  </a:extLst>
                </a:gridCol>
                <a:gridCol w="882341">
                  <a:extLst>
                    <a:ext uri="{9D8B030D-6E8A-4147-A177-3AD203B41FA5}">
                      <a16:colId xmlns:a16="http://schemas.microsoft.com/office/drawing/2014/main" val="1539900182"/>
                    </a:ext>
                  </a:extLst>
                </a:gridCol>
                <a:gridCol w="737385">
                  <a:extLst>
                    <a:ext uri="{9D8B030D-6E8A-4147-A177-3AD203B41FA5}">
                      <a16:colId xmlns:a16="http://schemas.microsoft.com/office/drawing/2014/main" val="1490682281"/>
                    </a:ext>
                  </a:extLst>
                </a:gridCol>
                <a:gridCol w="845495">
                  <a:extLst>
                    <a:ext uri="{9D8B030D-6E8A-4147-A177-3AD203B41FA5}">
                      <a16:colId xmlns:a16="http://schemas.microsoft.com/office/drawing/2014/main" val="2194558029"/>
                    </a:ext>
                  </a:extLst>
                </a:gridCol>
                <a:gridCol w="821740">
                  <a:extLst>
                    <a:ext uri="{9D8B030D-6E8A-4147-A177-3AD203B41FA5}">
                      <a16:colId xmlns:a16="http://schemas.microsoft.com/office/drawing/2014/main" val="341116941"/>
                    </a:ext>
                  </a:extLst>
                </a:gridCol>
              </a:tblGrid>
              <a:tr h="273703">
                <a:tc>
                  <a:txBody>
                    <a:bodyPr/>
                    <a:lstStyle/>
                    <a:p>
                      <a:pPr algn="ctr"/>
                      <a:r>
                        <a:rPr lang="en-IN" sz="600">
                          <a:effectLst/>
                        </a:rPr>
                        <a:t>Phenotype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600" dirty="0">
                          <a:effectLst/>
                        </a:rPr>
                        <a:t>Nonedited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600">
                          <a:effectLst/>
                        </a:rPr>
                        <a:t>1 b Insertio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600">
                          <a:effectLst/>
                        </a:rPr>
                        <a:t>23 b deletio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600">
                          <a:effectLst/>
                        </a:rPr>
                        <a:t>1 b deletio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417913831"/>
                  </a:ext>
                </a:extLst>
              </a:tr>
              <a:tr h="183498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Seed germination (days)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14-20 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4-6 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4-6 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4-6 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697244629"/>
                  </a:ext>
                </a:extLst>
              </a:tr>
              <a:tr h="161727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lant height (cm)*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75 ±10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60±8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60±6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60±7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605375253"/>
                  </a:ext>
                </a:extLst>
              </a:tr>
              <a:tr h="292186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Branching (No. branches/branchlets/internode length)*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/3/8.7±0.0.3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3/5-9/5.4±0.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3/6-9/5±0.4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3/5-9/5.6±0.7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199347945"/>
                  </a:ext>
                </a:extLst>
              </a:tr>
              <a:tr h="292186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Leaf length/breadth* (cm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Large (21.3±1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r>
                        <a:rPr lang="en-IN" sz="600" dirty="0">
                          <a:effectLst/>
                        </a:rPr>
                        <a:t>/19.5±0.8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r>
                        <a:rPr lang="en-IN" sz="600" dirty="0">
                          <a:effectLst/>
                        </a:rPr>
                        <a:t>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Small </a:t>
                      </a:r>
                    </a:p>
                    <a:p>
                      <a:r>
                        <a:rPr lang="en-IN" sz="600" dirty="0">
                          <a:effectLst/>
                        </a:rPr>
                        <a:t>(14.1±1.2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/9.4±0.9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Small (11.6±1.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/7.9.±1.4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Small </a:t>
                      </a:r>
                      <a:r>
                        <a:rPr lang="en-IN" sz="600" b="0" dirty="0">
                          <a:effectLst/>
                        </a:rPr>
                        <a:t>(14.9±1.4</a:t>
                      </a:r>
                      <a:r>
                        <a:rPr lang="en-IN" sz="600" b="0" baseline="30000" dirty="0">
                          <a:effectLst/>
                        </a:rPr>
                        <a:t>b</a:t>
                      </a:r>
                      <a:r>
                        <a:rPr lang="en-IN" sz="600" b="0" dirty="0">
                          <a:effectLst/>
                        </a:rPr>
                        <a:t>/9.5±1.3</a:t>
                      </a:r>
                      <a:r>
                        <a:rPr lang="en-IN" sz="600" b="0" baseline="30000" dirty="0">
                          <a:effectLst/>
                        </a:rPr>
                        <a:t>b</a:t>
                      </a:r>
                      <a:r>
                        <a:rPr lang="en-IN" sz="600" b="0" dirty="0">
                          <a:effectLst/>
                        </a:rPr>
                        <a:t>)</a:t>
                      </a:r>
                      <a:endParaRPr lang="en-IN" sz="6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588409633"/>
                  </a:ext>
                </a:extLst>
              </a:tr>
              <a:tr h="232555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eaf pubescence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Non-pubescent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ubescent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ubescent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ubescent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621919096"/>
                  </a:ext>
                </a:extLst>
              </a:tr>
              <a:tr h="292186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Spines on early leaves (</a:t>
                      </a:r>
                      <a:r>
                        <a:rPr lang="en-IN" sz="600" dirty="0" err="1">
                          <a:effectLst/>
                        </a:rPr>
                        <a:t>lamina+petiole</a:t>
                      </a:r>
                      <a:r>
                        <a:rPr lang="en-IN" sz="600" dirty="0">
                          <a:effectLst/>
                        </a:rPr>
                        <a:t>/calyx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Absent (rarely inconspicuous  spinules on calyx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8.3±1.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/few on calyx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3.9±2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r>
                        <a:rPr lang="en-IN" sz="600" dirty="0">
                          <a:effectLst/>
                        </a:rPr>
                        <a:t>/9.0±1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7.5±1.1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r>
                        <a:rPr lang="en-IN" sz="600" dirty="0">
                          <a:effectLst/>
                        </a:rPr>
                        <a:t>/few on calyx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1955438926"/>
                  </a:ext>
                </a:extLst>
              </a:tr>
              <a:tr h="201848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Thorns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Absent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Rare/fewer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High no.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Rare/fewer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170886649"/>
                  </a:ext>
                </a:extLst>
              </a:tr>
              <a:tr h="370778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Flowering time after germination (days)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70-75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45-55. Early flowering (mean of 25 days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45-55. Early flowering (mean of 23 days)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45-55. Early flowering (mean of 23 days)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3002723570"/>
                  </a:ext>
                </a:extLst>
              </a:tr>
              <a:tr h="370778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Inflorescence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Solitary  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Branched and solitary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Branched (mean of 4.3±0.4 flowers/infl.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Branched and solitary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3453397538"/>
                  </a:ext>
                </a:extLst>
              </a:tr>
              <a:tr h="278083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No. flowers 20 days from the first flower buds*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7.5±0.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9±0.2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3±0.5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2±1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1357478883"/>
                  </a:ext>
                </a:extLst>
              </a:tr>
              <a:tr h="278083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Flower </a:t>
                      </a:r>
                      <a:r>
                        <a:rPr lang="en-IN" sz="600" dirty="0" err="1">
                          <a:effectLst/>
                        </a:rPr>
                        <a:t>color</a:t>
                      </a:r>
                      <a:r>
                        <a:rPr lang="en-IN" sz="600" dirty="0">
                          <a:effectLst/>
                        </a:rPr>
                        <a:t>: mature/senescent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Whitish/lilac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ight Purplish /blue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urplish/blue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Purplish/blue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327327892"/>
                  </a:ext>
                </a:extLst>
              </a:tr>
              <a:tr h="278083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Fruit shape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Oval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ong, straight or curved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ong, straight or curved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ong, straight or curved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656765181"/>
                  </a:ext>
                </a:extLst>
              </a:tr>
              <a:tr h="193300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Fruit length (cm)***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2.5±1.2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4.7±1.5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5±2.0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4.3±2.5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3323398071"/>
                  </a:ext>
                </a:extLst>
              </a:tr>
              <a:tr h="207028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Fruit diameter (cm)***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1.3±1.5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8.4±1.7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8.6±1.5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7.6±1.9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3587834663"/>
                  </a:ext>
                </a:extLst>
              </a:tr>
              <a:tr h="197614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No. fruits* 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8.4±0.5</a:t>
                      </a:r>
                      <a:r>
                        <a:rPr lang="en-IN" sz="600" baseline="30000" dirty="0">
                          <a:effectLst/>
                        </a:rPr>
                        <a:t>c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4±2.2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1.5±1.8</a:t>
                      </a:r>
                      <a:r>
                        <a:rPr lang="en-IN" sz="600" baseline="30000" dirty="0">
                          <a:effectLst/>
                        </a:rPr>
                        <a:t>a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0.2±2.8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1542473805"/>
                  </a:ext>
                </a:extLst>
              </a:tr>
              <a:tr h="556167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Growth period with flowers and fruit set from germinatio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Few flowers and fruit set after 120 days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Continued the trend of more flowers and fruit set after 120 days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Continued the trend of more flowers and fruit set after 120 days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Continued the trend of more flowers and fruit set after 120 days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1435286630"/>
                  </a:ext>
                </a:extLst>
              </a:tr>
              <a:tr h="177825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Fruit weight (g)***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307±27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60±4.2</a:t>
                      </a:r>
                      <a:r>
                        <a:rPr lang="en-IN" sz="600" baseline="30000" dirty="0">
                          <a:effectLst/>
                        </a:rPr>
                        <a:t>c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25±8.3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30±11.6</a:t>
                      </a:r>
                      <a:r>
                        <a:rPr lang="en-IN" sz="60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3923270266"/>
                  </a:ext>
                </a:extLst>
              </a:tr>
              <a:tr h="292186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Fruit: vegetable harvest/mature seeds (days after pollination)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35/50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22/35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20/30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22/35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2240216644"/>
                  </a:ext>
                </a:extLst>
              </a:tr>
              <a:tr h="220663"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Number of seeds**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850±25</a:t>
                      </a:r>
                      <a:r>
                        <a:rPr lang="en-IN" sz="600" baseline="30000" dirty="0">
                          <a:effectLst/>
                        </a:rPr>
                        <a:t>a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50±30</a:t>
                      </a:r>
                      <a:r>
                        <a:rPr lang="en-IN" sz="600" baseline="30000" dirty="0">
                          <a:effectLst/>
                        </a:rPr>
                        <a:t>c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240±20</a:t>
                      </a:r>
                      <a:r>
                        <a:rPr lang="en-IN" sz="600" baseline="30000" dirty="0">
                          <a:effectLst/>
                        </a:rPr>
                        <a:t>c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350±25</a:t>
                      </a:r>
                      <a:r>
                        <a:rPr lang="en-IN" sz="600" b="0" baseline="30000" dirty="0">
                          <a:effectLst/>
                        </a:rPr>
                        <a:t>b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4093224839"/>
                  </a:ext>
                </a:extLst>
              </a:tr>
              <a:tr h="370778"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Fruit browning time: slices/tissue scoop/juice 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10 min/5 min/3 min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ess browning after 24 h/1 h/30 mi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>
                          <a:effectLst/>
                        </a:rPr>
                        <a:t>Less browning after 24 h/1 h/30 min</a:t>
                      </a:r>
                      <a:endParaRPr lang="en-IN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tc>
                  <a:txBody>
                    <a:bodyPr/>
                    <a:lstStyle/>
                    <a:p>
                      <a:r>
                        <a:rPr lang="en-IN" sz="600" dirty="0">
                          <a:effectLst/>
                        </a:rPr>
                        <a:t>Less browning after 24 h/1 h/30 min</a:t>
                      </a:r>
                      <a:endParaRPr lang="en-IN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635" marR="32635" marT="0" marB="0"/>
                </a:tc>
                <a:extLst>
                  <a:ext uri="{0D108BD9-81ED-4DB2-BD59-A6C34878D82A}">
                    <a16:rowId xmlns:a16="http://schemas.microsoft.com/office/drawing/2014/main" val="1376196874"/>
                  </a:ext>
                </a:extLst>
              </a:tr>
            </a:tbl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FF4119A4-9326-CC7E-2A7B-5541BDD091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7145" y="6288259"/>
            <a:ext cx="4867223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Mean of 6 plants; ** Mean of 5 fruits.  *** Mean of at least 10 measurements. </a:t>
            </a:r>
            <a:r>
              <a:rPr lang="en-US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</a:t>
            </a:r>
            <a:r>
              <a:rPr lang="en-IN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± SE.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values followed by the same letters within rows are not significantly different </a:t>
            </a:r>
            <a:r>
              <a:rPr lang="en-IN" sz="1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P &lt; 0.05)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1AEB91-D084-12CE-2347-B4E427993B0B}"/>
              </a:ext>
            </a:extLst>
          </p:cNvPr>
          <p:cNvSpPr txBox="1"/>
          <p:nvPr/>
        </p:nvSpPr>
        <p:spPr>
          <a:xfrm>
            <a:off x="7107154" y="128440"/>
            <a:ext cx="485661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3 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otypic features of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PO2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edited plants in comparison to Non-Edited plants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6887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2</TotalTime>
  <Words>905</Words>
  <Application>Microsoft Macintosh PowerPoint</Application>
  <PresentationFormat>Widescreen</PresentationFormat>
  <Paragraphs>12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Kottackal</dc:creator>
  <cp:lastModifiedBy>Martin Kottackal</cp:lastModifiedBy>
  <cp:revision>304</cp:revision>
  <cp:lastPrinted>2022-11-18T09:59:16Z</cp:lastPrinted>
  <dcterms:created xsi:type="dcterms:W3CDTF">2022-11-04T17:27:50Z</dcterms:created>
  <dcterms:modified xsi:type="dcterms:W3CDTF">2023-01-17T04:07:47Z</dcterms:modified>
</cp:coreProperties>
</file>